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96" r:id="rId2"/>
    <p:sldId id="289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6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Picture 91">
            <a:extLst>
              <a:ext uri="{FF2B5EF4-FFF2-40B4-BE49-F238E27FC236}">
                <a16:creationId xmlns:a16="http://schemas.microsoft.com/office/drawing/2014/main" id="{014D6148-3E03-264A-8723-017EFE43BA7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854" t="2653" r="27860" b="7202"/>
          <a:stretch/>
        </p:blipFill>
        <p:spPr>
          <a:xfrm>
            <a:off x="4708736" y="3266706"/>
            <a:ext cx="1758714" cy="1958400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BB5D3B03-8E9F-4A4B-B653-9247104EA2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460" t="2647" r="28221" b="8917"/>
          <a:stretch/>
        </p:blipFill>
        <p:spPr>
          <a:xfrm>
            <a:off x="4719622" y="994554"/>
            <a:ext cx="1760753" cy="19584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F30133E-50B0-D54E-B4D1-4B6535CDFC59}"/>
              </a:ext>
            </a:extLst>
          </p:cNvPr>
          <p:cNvSpPr txBox="1"/>
          <p:nvPr/>
        </p:nvSpPr>
        <p:spPr>
          <a:xfrm>
            <a:off x="5933981" y="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</a:rPr>
              <a:t>Sup 1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2E6975-0DF1-D947-9E85-DC0241AA0950}"/>
              </a:ext>
            </a:extLst>
          </p:cNvPr>
          <p:cNvSpPr txBox="1"/>
          <p:nvPr/>
        </p:nvSpPr>
        <p:spPr>
          <a:xfrm>
            <a:off x="34680" y="314718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00465AE-CF52-344F-B775-0CBD8472C34B}"/>
              </a:ext>
            </a:extLst>
          </p:cNvPr>
          <p:cNvSpPr txBox="1"/>
          <p:nvPr/>
        </p:nvSpPr>
        <p:spPr>
          <a:xfrm rot="16200000">
            <a:off x="-106352" y="1874631"/>
            <a:ext cx="623479" cy="21736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Testis 80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68FC3B1-71AA-8C4C-A593-FFCAAA75B9CB}"/>
              </a:ext>
            </a:extLst>
          </p:cNvPr>
          <p:cNvSpPr txBox="1"/>
          <p:nvPr/>
        </p:nvSpPr>
        <p:spPr>
          <a:xfrm rot="16200000">
            <a:off x="-249161" y="4092018"/>
            <a:ext cx="9090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Ovary 80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FA35E01-AA7C-3845-8757-359A5D3E3D89}"/>
              </a:ext>
            </a:extLst>
          </p:cNvPr>
          <p:cNvSpPr txBox="1"/>
          <p:nvPr/>
        </p:nvSpPr>
        <p:spPr>
          <a:xfrm>
            <a:off x="34680" y="5361200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G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70B1DE9-F815-AA4A-94A3-21BC31F3AA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9962" y="5516240"/>
            <a:ext cx="2462369" cy="1934125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654EB722-F661-7F49-B967-587DC5521707}"/>
              </a:ext>
            </a:extLst>
          </p:cNvPr>
          <p:cNvSpPr txBox="1"/>
          <p:nvPr/>
        </p:nvSpPr>
        <p:spPr>
          <a:xfrm>
            <a:off x="1968077" y="5361200"/>
            <a:ext cx="328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H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7F6A923A-FD4C-9247-80A9-C3E8C21F59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8487" y="5621820"/>
            <a:ext cx="599425" cy="594075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E4C0712F-A750-F442-AF61-D816C290F6C5}"/>
              </a:ext>
            </a:extLst>
          </p:cNvPr>
          <p:cNvSpPr txBox="1"/>
          <p:nvPr/>
        </p:nvSpPr>
        <p:spPr>
          <a:xfrm>
            <a:off x="2998707" y="7365971"/>
            <a:ext cx="10262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Resolution (1/</a:t>
            </a:r>
            <a:r>
              <a:rPr lang="en-US" sz="1000" err="1">
                <a:latin typeface="+mj-lt"/>
                <a:cs typeface="Arial" panose="020B0604020202020204" pitchFamily="34" charset="0"/>
              </a:rPr>
              <a:t>Å</a:t>
            </a:r>
            <a:r>
              <a:rPr lang="en-US" sz="1000">
                <a:latin typeface="+mj-lt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5AB9D67-1048-7441-8B15-EB3BD86754F1}"/>
              </a:ext>
            </a:extLst>
          </p:cNvPr>
          <p:cNvSpPr txBox="1"/>
          <p:nvPr/>
        </p:nvSpPr>
        <p:spPr>
          <a:xfrm rot="16200000">
            <a:off x="1432398" y="6326499"/>
            <a:ext cx="1451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Fourier Shell Correlatio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D76B449-31DF-D54A-99F4-B7995AD2499B}"/>
              </a:ext>
            </a:extLst>
          </p:cNvPr>
          <p:cNvSpPr txBox="1"/>
          <p:nvPr/>
        </p:nvSpPr>
        <p:spPr>
          <a:xfrm>
            <a:off x="2776938" y="5342780"/>
            <a:ext cx="1482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Resolution = 4.9 </a:t>
            </a:r>
            <a:r>
              <a:rPr lang="en-US" sz="1400" err="1">
                <a:latin typeface="+mj-lt"/>
                <a:cs typeface="Arial" panose="020B0604020202020204" pitchFamily="34" charset="0"/>
              </a:rPr>
              <a:t>Å</a:t>
            </a:r>
            <a:endParaRPr lang="en-US" sz="140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A9A99EC0-B89A-1A44-8BB1-53429FEAC0C0}"/>
              </a:ext>
            </a:extLst>
          </p:cNvPr>
          <p:cNvGrpSpPr/>
          <p:nvPr/>
        </p:nvGrpSpPr>
        <p:grpSpPr>
          <a:xfrm>
            <a:off x="381251" y="5680011"/>
            <a:ext cx="1591597" cy="1591598"/>
            <a:chOff x="381251" y="5179285"/>
            <a:chExt cx="1591597" cy="159159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53C1C1C-C360-8343-BC80-01045F2CB64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1251" y="5179285"/>
              <a:ext cx="1591597" cy="1591598"/>
            </a:xfrm>
            <a:prstGeom prst="rect">
              <a:avLst/>
            </a:prstGeom>
          </p:spPr>
        </p:pic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BE77767A-D008-EC48-99DC-472E73CCC982}"/>
                </a:ext>
              </a:extLst>
            </p:cNvPr>
            <p:cNvCxnSpPr/>
            <p:nvPr/>
          </p:nvCxnSpPr>
          <p:spPr>
            <a:xfrm>
              <a:off x="1754812" y="6720221"/>
              <a:ext cx="18051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9" name="Picture 38">
            <a:extLst>
              <a:ext uri="{FF2B5EF4-FFF2-40B4-BE49-F238E27FC236}">
                <a16:creationId xmlns:a16="http://schemas.microsoft.com/office/drawing/2014/main" id="{06A8B620-1C6D-E74B-B3E9-E3CCEE7704A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8532" t="2877" r="26974" b="7307"/>
          <a:stretch/>
        </p:blipFill>
        <p:spPr>
          <a:xfrm>
            <a:off x="4719622" y="5610135"/>
            <a:ext cx="1772965" cy="1959592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CD291D21-0844-1B4C-9387-861E04388194}"/>
              </a:ext>
            </a:extLst>
          </p:cNvPr>
          <p:cNvSpPr txBox="1"/>
          <p:nvPr/>
        </p:nvSpPr>
        <p:spPr>
          <a:xfrm>
            <a:off x="4682331" y="5361200"/>
            <a:ext cx="242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I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8041663A-111A-1B47-A392-45A1361C106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574" t="27059" r="23882" b="57026"/>
          <a:stretch/>
        </p:blipFill>
        <p:spPr>
          <a:xfrm>
            <a:off x="6407469" y="5610135"/>
            <a:ext cx="231580" cy="697305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C183B29D-D66D-A442-A329-4A41B9D2B61E}"/>
              </a:ext>
            </a:extLst>
          </p:cNvPr>
          <p:cNvSpPr txBox="1"/>
          <p:nvPr/>
        </p:nvSpPr>
        <p:spPr>
          <a:xfrm>
            <a:off x="4682331" y="3147187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ACF6830-E643-414F-ABE7-35DDA5D16EBA}"/>
              </a:ext>
            </a:extLst>
          </p:cNvPr>
          <p:cNvSpPr txBox="1"/>
          <p:nvPr/>
        </p:nvSpPr>
        <p:spPr>
          <a:xfrm rot="16200000">
            <a:off x="-489382" y="6354610"/>
            <a:ext cx="1406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Testis </a:t>
            </a:r>
            <a:r>
              <a:rPr lang="en-US" sz="1400" err="1">
                <a:latin typeface="+mj-lt"/>
                <a:cs typeface="Arial" panose="020B0604020202020204" pitchFamily="34" charset="0"/>
              </a:rPr>
              <a:t>Polysomes</a:t>
            </a:r>
            <a:endParaRPr lang="en-US" sz="140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E3581E9-CE04-564C-B725-6BD9F8DB5F3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34035" y="3302251"/>
            <a:ext cx="2441957" cy="1914271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587B38E6-D4D3-E04C-BEE3-67BACFC15F8C}"/>
              </a:ext>
            </a:extLst>
          </p:cNvPr>
          <p:cNvSpPr txBox="1"/>
          <p:nvPr/>
        </p:nvSpPr>
        <p:spPr>
          <a:xfrm>
            <a:off x="2753806" y="3111067"/>
            <a:ext cx="1482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Resolution = 3.0 </a:t>
            </a:r>
            <a:r>
              <a:rPr lang="en-US" sz="1400" err="1">
                <a:latin typeface="+mj-lt"/>
                <a:cs typeface="Arial" panose="020B0604020202020204" pitchFamily="34" charset="0"/>
              </a:rPr>
              <a:t>Å</a:t>
            </a:r>
            <a:endParaRPr lang="en-US" sz="140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2A6D215E-B758-D442-BD2C-A29E453018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3511" y="3366675"/>
            <a:ext cx="599426" cy="594075"/>
          </a:xfrm>
          <a:prstGeom prst="rect">
            <a:avLst/>
          </a:prstGeom>
        </p:spPr>
      </p:pic>
      <p:sp>
        <p:nvSpPr>
          <p:cNvPr id="57" name="TextBox 56">
            <a:extLst>
              <a:ext uri="{FF2B5EF4-FFF2-40B4-BE49-F238E27FC236}">
                <a16:creationId xmlns:a16="http://schemas.microsoft.com/office/drawing/2014/main" id="{DFBA0F85-7D97-B644-BA4E-6E51CE9774B2}"/>
              </a:ext>
            </a:extLst>
          </p:cNvPr>
          <p:cNvSpPr txBox="1"/>
          <p:nvPr/>
        </p:nvSpPr>
        <p:spPr>
          <a:xfrm>
            <a:off x="2983730" y="5119898"/>
            <a:ext cx="10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Resolution (1/</a:t>
            </a:r>
            <a:r>
              <a:rPr lang="en-US" sz="1000" err="1">
                <a:latin typeface="+mj-lt"/>
                <a:cs typeface="Arial" panose="020B0604020202020204" pitchFamily="34" charset="0"/>
              </a:rPr>
              <a:t>Å</a:t>
            </a:r>
            <a:r>
              <a:rPr lang="en-US" sz="1000">
                <a:latin typeface="+mj-lt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AB865AE-6265-6048-B6C9-42F9FDDC399F}"/>
              </a:ext>
            </a:extLst>
          </p:cNvPr>
          <p:cNvSpPr txBox="1"/>
          <p:nvPr/>
        </p:nvSpPr>
        <p:spPr>
          <a:xfrm rot="16200000">
            <a:off x="1428762" y="4071354"/>
            <a:ext cx="14510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Fourier Shell Correlation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6FB6B6FD-1BF9-6540-A682-F6170E8D79A5}"/>
              </a:ext>
            </a:extLst>
          </p:cNvPr>
          <p:cNvGrpSpPr/>
          <p:nvPr/>
        </p:nvGrpSpPr>
        <p:grpSpPr>
          <a:xfrm>
            <a:off x="381955" y="3430887"/>
            <a:ext cx="1590893" cy="1590893"/>
            <a:chOff x="381955" y="2770402"/>
            <a:chExt cx="1590893" cy="1590893"/>
          </a:xfrm>
        </p:grpSpPr>
        <p:pic>
          <p:nvPicPr>
            <p:cNvPr id="13" name="Picture 2" descr="ovaries1.png">
              <a:extLst>
                <a:ext uri="{FF2B5EF4-FFF2-40B4-BE49-F238E27FC236}">
                  <a16:creationId xmlns:a16="http://schemas.microsoft.com/office/drawing/2014/main" id="{BACC2EE0-8FB0-134B-8D57-56180D4B0CC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955" y="2770402"/>
              <a:ext cx="1590893" cy="1590893"/>
            </a:xfrm>
            <a:prstGeom prst="rect">
              <a:avLst/>
            </a:prstGeom>
            <a:noFill/>
            <a:ln w="19050"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7E9E2FB8-C5B0-3B40-92DD-318CFCAB2949}"/>
                </a:ext>
              </a:extLst>
            </p:cNvPr>
            <p:cNvCxnSpPr/>
            <p:nvPr/>
          </p:nvCxnSpPr>
          <p:spPr>
            <a:xfrm>
              <a:off x="1755379" y="4315625"/>
              <a:ext cx="18051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14EFF802-A0CB-724B-B490-59B8D9DFEB6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215892" y="1017287"/>
            <a:ext cx="2440557" cy="1922779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B53F233F-51C7-9847-8CC1-462C9ACC8563}"/>
              </a:ext>
            </a:extLst>
          </p:cNvPr>
          <p:cNvSpPr txBox="1"/>
          <p:nvPr/>
        </p:nvSpPr>
        <p:spPr>
          <a:xfrm>
            <a:off x="2764710" y="822853"/>
            <a:ext cx="1482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>
                <a:latin typeface="+mj-lt"/>
                <a:cs typeface="Arial" panose="020B0604020202020204" pitchFamily="34" charset="0"/>
              </a:rPr>
              <a:t>Resolution = 3.5 </a:t>
            </a:r>
            <a:r>
              <a:rPr lang="en-US" sz="1400" err="1">
                <a:latin typeface="+mj-lt"/>
                <a:cs typeface="Arial" panose="020B0604020202020204" pitchFamily="34" charset="0"/>
              </a:rPr>
              <a:t>Å</a:t>
            </a:r>
            <a:endParaRPr lang="en-US" sz="1400">
              <a:latin typeface="+mj-lt"/>
              <a:cs typeface="Arial" panose="020B0604020202020204" pitchFamily="34" charset="0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5B5D445D-4929-2849-8106-158A1F25104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4420" y="1122867"/>
            <a:ext cx="599426" cy="594075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5E89FEA2-C3EB-504B-8EAA-6EB7ACE82598}"/>
              </a:ext>
            </a:extLst>
          </p:cNvPr>
          <p:cNvSpPr txBox="1"/>
          <p:nvPr/>
        </p:nvSpPr>
        <p:spPr>
          <a:xfrm>
            <a:off x="2994639" y="2877903"/>
            <a:ext cx="10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Resolution (1/</a:t>
            </a:r>
            <a:r>
              <a:rPr lang="en-US" sz="1000" err="1">
                <a:latin typeface="+mj-lt"/>
                <a:cs typeface="Arial" panose="020B0604020202020204" pitchFamily="34" charset="0"/>
              </a:rPr>
              <a:t>Å</a:t>
            </a:r>
            <a:r>
              <a:rPr lang="en-US" sz="1000">
                <a:latin typeface="+mj-lt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3EAF1AD-B135-114B-819D-B1646A3DC6D0}"/>
              </a:ext>
            </a:extLst>
          </p:cNvPr>
          <p:cNvSpPr txBox="1"/>
          <p:nvPr/>
        </p:nvSpPr>
        <p:spPr>
          <a:xfrm rot="16200000">
            <a:off x="1439669" y="1827545"/>
            <a:ext cx="14510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>
                <a:latin typeface="+mj-lt"/>
                <a:cs typeface="Arial" panose="020B0604020202020204" pitchFamily="34" charset="0"/>
              </a:rPr>
              <a:t>Fourier Shell Correlation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CD171736-EA4E-F14C-BBFA-F9D0B0D3DF64}"/>
              </a:ext>
            </a:extLst>
          </p:cNvPr>
          <p:cNvGrpSpPr/>
          <p:nvPr/>
        </p:nvGrpSpPr>
        <p:grpSpPr>
          <a:xfrm>
            <a:off x="381251" y="1188575"/>
            <a:ext cx="1591597" cy="1591598"/>
            <a:chOff x="381251" y="654101"/>
            <a:chExt cx="1591597" cy="159159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3DF2D4B-1B9D-8442-B9F3-5C17117D722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81251" y="654101"/>
              <a:ext cx="1591597" cy="1591598"/>
            </a:xfrm>
            <a:prstGeom prst="rect">
              <a:avLst/>
            </a:prstGeom>
          </p:spPr>
        </p:pic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E5AC39E8-C26F-9248-A16F-CB5A6642EC62}"/>
                </a:ext>
              </a:extLst>
            </p:cNvPr>
            <p:cNvCxnSpPr/>
            <p:nvPr/>
          </p:nvCxnSpPr>
          <p:spPr>
            <a:xfrm>
              <a:off x="1755379" y="2202073"/>
              <a:ext cx="18051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D96BBB06-F327-FF43-AAE6-E203401943E3}"/>
              </a:ext>
            </a:extLst>
          </p:cNvPr>
          <p:cNvSpPr txBox="1"/>
          <p:nvPr/>
        </p:nvSpPr>
        <p:spPr>
          <a:xfrm>
            <a:off x="96062" y="82285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E61390D-72E4-C74B-A618-407C2E84E982}"/>
              </a:ext>
            </a:extLst>
          </p:cNvPr>
          <p:cNvSpPr txBox="1"/>
          <p:nvPr/>
        </p:nvSpPr>
        <p:spPr>
          <a:xfrm>
            <a:off x="1986862" y="82285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9E69ECC-C027-F24C-B90B-ED71365547F4}"/>
              </a:ext>
            </a:extLst>
          </p:cNvPr>
          <p:cNvSpPr txBox="1"/>
          <p:nvPr/>
        </p:nvSpPr>
        <p:spPr>
          <a:xfrm>
            <a:off x="4682331" y="82285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7E18F36-F85A-504A-9F16-C075F751AE18}"/>
              </a:ext>
            </a:extLst>
          </p:cNvPr>
          <p:cNvSpPr txBox="1"/>
          <p:nvPr/>
        </p:nvSpPr>
        <p:spPr>
          <a:xfrm>
            <a:off x="2006098" y="314718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1266F85B-3F49-A745-9F20-5960E8289A7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574" t="27059" r="23882" b="57026"/>
          <a:stretch/>
        </p:blipFill>
        <p:spPr>
          <a:xfrm>
            <a:off x="6407469" y="3266706"/>
            <a:ext cx="231580" cy="697305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C6D63D8E-629C-B646-83AA-269ECF1509D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574" t="27059" r="23882" b="57026"/>
          <a:stretch/>
        </p:blipFill>
        <p:spPr>
          <a:xfrm>
            <a:off x="6401876" y="994554"/>
            <a:ext cx="231580" cy="69730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C0AE9A07-12BD-FA43-B19D-4FF3228219BD}"/>
              </a:ext>
            </a:extLst>
          </p:cNvPr>
          <p:cNvSpPr/>
          <p:nvPr/>
        </p:nvSpPr>
        <p:spPr>
          <a:xfrm>
            <a:off x="-284418" y="8032063"/>
            <a:ext cx="6900156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/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 10: Cryo-electron microscopy of testis and ovary ribosomes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457200"/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yo-electron micrographs (A, D and G), FSC curves (B, E and H) and local resolution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ured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aps (C, F and I) for the cryo-EM averages of testis 80S (A-C), ovary 80S (D-F) and testis polysomes (G-I). Scale bars for A, D &amp; G are 50 nm. 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4489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FF30133E-50B0-D54E-B4D1-4B6535CDFC59}"/>
              </a:ext>
            </a:extLst>
          </p:cNvPr>
          <p:cNvSpPr txBox="1"/>
          <p:nvPr/>
        </p:nvSpPr>
        <p:spPr>
          <a:xfrm>
            <a:off x="5933981" y="0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+mj-lt"/>
                <a:cs typeface="Calibri" panose="020F0502020204030204" pitchFamily="34" charset="0"/>
              </a:rPr>
              <a:t>Sup 11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E77767A-D008-EC48-99DC-472E73CCC982}"/>
              </a:ext>
            </a:extLst>
          </p:cNvPr>
          <p:cNvCxnSpPr/>
          <p:nvPr/>
        </p:nvCxnSpPr>
        <p:spPr>
          <a:xfrm>
            <a:off x="6312483" y="4154398"/>
            <a:ext cx="1805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Picture 59">
            <a:extLst>
              <a:ext uri="{FF2B5EF4-FFF2-40B4-BE49-F238E27FC236}">
                <a16:creationId xmlns:a16="http://schemas.microsoft.com/office/drawing/2014/main" id="{0FADB755-4592-6F40-9940-0432375CB1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099" t="27873" r="38227" b="26069"/>
          <a:stretch/>
        </p:blipFill>
        <p:spPr>
          <a:xfrm>
            <a:off x="4399505" y="3397809"/>
            <a:ext cx="2034980" cy="2118167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7099AFA1-1B3B-EC48-B540-9DBEBB87B81C}"/>
              </a:ext>
            </a:extLst>
          </p:cNvPr>
          <p:cNvSpPr txBox="1"/>
          <p:nvPr/>
        </p:nvSpPr>
        <p:spPr>
          <a:xfrm>
            <a:off x="4628409" y="5572663"/>
            <a:ext cx="1702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>
                <a:solidFill>
                  <a:srgbClr val="FBC214"/>
                </a:solidFill>
                <a:effectLst>
                  <a:outerShdw dist="12700" dir="2700000" algn="tl" rotWithShape="0">
                    <a:prstClr val="black"/>
                  </a:outerShdw>
                </a:effectLst>
                <a:latin typeface="+mj-lt"/>
              </a:rPr>
              <a:t>IFRD1 – </a:t>
            </a:r>
            <a:r>
              <a:rPr lang="en-GB" sz="1200" i="1">
                <a:solidFill>
                  <a:srgbClr val="FBC214"/>
                </a:solidFill>
                <a:effectLst>
                  <a:outerShdw dist="12700" dir="2700000" algn="tl" rotWithShape="0">
                    <a:prstClr val="black"/>
                  </a:outerShdw>
                </a:effectLst>
                <a:latin typeface="+mj-lt"/>
              </a:rPr>
              <a:t>D. melanogaster</a:t>
            </a:r>
            <a:endParaRPr lang="en-US" sz="1200" i="1">
              <a:solidFill>
                <a:srgbClr val="FBC214"/>
              </a:solidFill>
              <a:effectLst>
                <a:outerShdw dist="12700" dir="2700000" algn="tl" rotWithShape="0">
                  <a:prstClr val="black"/>
                </a:outerShdw>
              </a:effectLst>
              <a:latin typeface="+mj-lt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7E003A2-BAEA-454D-BDD5-7935CF110D8C}"/>
              </a:ext>
            </a:extLst>
          </p:cNvPr>
          <p:cNvSpPr txBox="1"/>
          <p:nvPr/>
        </p:nvSpPr>
        <p:spPr>
          <a:xfrm>
            <a:off x="4628409" y="5767849"/>
            <a:ext cx="1091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>
                <a:solidFill>
                  <a:srgbClr val="00FDFF"/>
                </a:solidFill>
                <a:effectLst>
                  <a:outerShdw dist="12700" dir="2700000" algn="tl" rotWithShape="0">
                    <a:prstClr val="black"/>
                  </a:outerShdw>
                </a:effectLst>
                <a:latin typeface="+mj-lt"/>
              </a:rPr>
              <a:t>IFRD2 – Rabbit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183B29D-D66D-A442-A329-4A41B9D2B61E}"/>
              </a:ext>
            </a:extLst>
          </p:cNvPr>
          <p:cNvSpPr txBox="1"/>
          <p:nvPr/>
        </p:nvSpPr>
        <p:spPr>
          <a:xfrm>
            <a:off x="4456019" y="323582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183B29D-D66D-A442-A329-4A41B9D2B61E}"/>
              </a:ext>
            </a:extLst>
          </p:cNvPr>
          <p:cNvSpPr txBox="1"/>
          <p:nvPr/>
        </p:nvSpPr>
        <p:spPr>
          <a:xfrm>
            <a:off x="209097" y="268104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7E9E2FB8-C5B0-3B40-92DD-318CFCAB2949}"/>
              </a:ext>
            </a:extLst>
          </p:cNvPr>
          <p:cNvCxnSpPr/>
          <p:nvPr/>
        </p:nvCxnSpPr>
        <p:spPr>
          <a:xfrm>
            <a:off x="1755379" y="4315625"/>
            <a:ext cx="1805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5AC39E8-C26F-9248-A16F-CB5A6642EC62}"/>
              </a:ext>
            </a:extLst>
          </p:cNvPr>
          <p:cNvCxnSpPr/>
          <p:nvPr/>
        </p:nvCxnSpPr>
        <p:spPr>
          <a:xfrm>
            <a:off x="1755379" y="2202073"/>
            <a:ext cx="1805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95F284C1-360D-4A48-8528-C8C04DB121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5000" y="3282541"/>
            <a:ext cx="3652858" cy="291148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467B3E4-38DC-2143-A9FA-727F5D8162AD}"/>
              </a:ext>
            </a:extLst>
          </p:cNvPr>
          <p:cNvSpPr/>
          <p:nvPr/>
        </p:nvSpPr>
        <p:spPr>
          <a:xfrm>
            <a:off x="-245551" y="6974411"/>
            <a:ext cx="596592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/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 11: Comparison between rabbit IFRD2 and </a:t>
            </a:r>
            <a:r>
              <a:rPr lang="en-US" sz="1100" b="1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 melanogaster</a:t>
            </a: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FRD1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marL="457200"/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100" dirty="0" err="1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ustal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omega alignment of rabbit IFRD2, and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 melanogaster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FRD1 protein sequence. (B) Comparison of the atomic models of rabbit IFRD2 and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 melanogaster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FRD1.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6941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87</Words>
  <Application>Microsoft Macintosh PowerPoint</Application>
  <PresentationFormat>A4 Paper (210x297 mm)</PresentationFormat>
  <Paragraphs>3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5</cp:revision>
  <cp:lastPrinted>2021-04-23T12:48:59Z</cp:lastPrinted>
  <dcterms:created xsi:type="dcterms:W3CDTF">2019-05-17T07:50:07Z</dcterms:created>
  <dcterms:modified xsi:type="dcterms:W3CDTF">2021-06-22T07:04:53Z</dcterms:modified>
</cp:coreProperties>
</file>